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7" r:id="rId3"/>
    <p:sldId id="268" r:id="rId4"/>
    <p:sldId id="269" r:id="rId5"/>
    <p:sldId id="270" r:id="rId6"/>
    <p:sldId id="271" r:id="rId7"/>
    <p:sldId id="272" r:id="rId8"/>
    <p:sldId id="273" r:id="rId9"/>
    <p:sldId id="287" r:id="rId10"/>
  </p:sldIdLst>
  <p:sldSz cx="12192000" cy="6858000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66FF66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09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9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3D12A4-3267-5DAD-02D5-E8A28667B2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CB51BB1-7A9A-E4EB-7775-96F9C24BEC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C7852C4-1609-11B8-B038-F40F5297D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1B3584D-C1C4-41DF-F72C-7FE7BE535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152190D-81BB-C6D5-D53F-B471EA039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7844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1EA5D4B-4E26-C09F-30A9-4BA3DC957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22C44E0-3C3D-01D5-1951-05935917A7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0D82BF3-AEC5-4261-912C-E2A3AFA9A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A3862D0-BFF0-2A0C-3B8F-9DF0F1FBD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353481D-6F24-9B16-08F1-4A7286BF9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4090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C1C7FE6-67CE-2A6B-A025-B8C6041063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0B3BC21-9542-F9EB-50E2-06AEF948A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4FA7530-C3EA-E6FE-03F4-DE1C22022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DC6C17B-4967-6AD4-C404-BDE5F2F7C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7086EB-B39E-D617-DFA1-22F81E96E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3553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65BC93-C622-D564-04DD-3163BBD7D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A612A2-2E46-0BCD-2077-96DCFFD645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83E7396-00CC-5B92-249C-F76CC2B54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D5A7E3-7546-B85A-1A45-35F289EC1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45CBF0-6838-7ECD-6405-90A0605CA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8004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B8322F-A99D-690C-2A9B-68B1B7D655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8B6897E-F0EA-54D7-EA21-571409B6EA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562CFC2-EC8F-B441-68FF-0C9BF15A2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390CFCF-161D-1A2B-72E4-BDBD9A094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E185F04-CFD7-6325-1817-D755A0BC6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8129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80CF781-F85A-8443-1717-B31324100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44D7D18-3C16-5D84-6DD4-971B8CA30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AA3DFEE-E81F-CF72-8419-B2DAFA304A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EE8858D-5659-8A3A-6348-DFE11FE8B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DF3DE3C-B049-F1E3-E952-1E83636CA8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93AB55-34C1-164E-B52C-1F70927E9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1690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B1E37D-AB08-682C-E3FB-86CBA21AA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50C261A-849B-B880-CFB3-07A74989A8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B8A2E2E-2C89-A54B-8EE1-5D47998BA7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A7042FB-BAAE-55B9-3864-09D1481DEC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955BEC1-6918-FF9C-BDB5-EF447130B0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7075CA7-7D1D-0872-4618-005D16C24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CE86C5E-AEE4-1554-9775-186832C79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4AACFB6-530D-78CF-944B-692A5883C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1059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5D9D4C1-E14A-E071-E35A-C9A5A601D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FF99B3F-76A3-728E-6CD2-F9D8A2061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BB0CF3D-8F73-2FAA-3C80-9C0657721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0C36175-0DB2-1CDD-6DF3-F07F82048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4891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05B5273-4803-4716-BF65-5952FF52C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07A1F32-2021-BE90-32A0-3A60F0BFB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EE69514-86F6-F51A-8467-636BF06C8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6937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D1C15C-6622-5767-3B64-787E4C2F3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52B222B-E15A-462D-4894-FA4F54AEBD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C798036-B180-8ECE-E1B0-5E4E2FA052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F7BC784-B303-20FF-1C1C-D5ACB648E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A6F4FED-69DD-36E4-47D7-5EAF5FAD6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F2AA193-4999-81BC-D14A-F28393A3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730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9B018E-DA39-20A1-5571-94E70F92E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8298254-777C-4E4A-986B-C01FAECCD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D824D90-CBF9-8119-C67B-C73AC2C826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AEAE09A-207F-CCC0-6FBD-A1077A3C7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08967FB-85C0-D6DF-7EE9-AC7840C01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506107B-79FC-2318-7621-D80A4B520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28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50AF970-6586-E37F-933C-24995F8E7B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233B9C3-9843-4D2C-B90A-C10558C11A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1C3C4D9-E6BD-406F-F70D-81C3EF5B5B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3591EB-B34B-49FA-AC01-C52A205EAB22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397B7D-4F1E-BC1A-F721-309E4B82EA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FCC8A4-8EDF-20B3-9BE4-8D8E6CC1D0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7309F-B27A-4314-A595-27D83E2112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2804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9C4F4CA7-D37F-5999-4B9E-73BA088E7A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568261">
            <a:off x="2684714" y="613539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0F2C96-FC87-DCA5-172B-EA217D1FF36A}"/>
              </a:ext>
            </a:extLst>
          </p:cNvPr>
          <p:cNvSpPr txBox="1"/>
          <p:nvPr/>
        </p:nvSpPr>
        <p:spPr>
          <a:xfrm>
            <a:off x="0" y="0"/>
            <a:ext cx="1967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ontrol E15-E16</a:t>
            </a:r>
          </a:p>
        </p:txBody>
      </p:sp>
    </p:spTree>
    <p:extLst>
      <p:ext uri="{BB962C8B-B14F-4D97-AF65-F5344CB8AC3E}">
        <p14:creationId xmlns:p14="http://schemas.microsoft.com/office/powerpoint/2010/main" val="37267397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7F142B48-0CD1-5E00-0FF2-ABEB960E36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568261">
            <a:off x="2684714" y="613539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60814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68F9557C-C53E-4A09-ACCC-A8F65B8DBD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568261">
            <a:off x="2684714" y="613539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73845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C22C6779-2FDE-D26E-7973-C7AD99C389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568261">
            <a:off x="2684714" y="613539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0100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4040EB6A-1F4C-4C89-87D9-B8178654AD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7197">
            <a:off x="2573504" y="674869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0F2C96-FC87-DCA5-172B-EA217D1FF36A}"/>
              </a:ext>
            </a:extLst>
          </p:cNvPr>
          <p:cNvSpPr txBox="1"/>
          <p:nvPr/>
        </p:nvSpPr>
        <p:spPr>
          <a:xfrm>
            <a:off x="0" y="0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lx2oe E15-E16</a:t>
            </a:r>
          </a:p>
        </p:txBody>
      </p:sp>
    </p:spTree>
    <p:extLst>
      <p:ext uri="{BB962C8B-B14F-4D97-AF65-F5344CB8AC3E}">
        <p14:creationId xmlns:p14="http://schemas.microsoft.com/office/powerpoint/2010/main" val="33403525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692B6941-E375-87E9-2CA3-1D4D8F23A5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7197">
            <a:off x="2573504" y="674869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0F2C96-FC87-DCA5-172B-EA217D1FF36A}"/>
              </a:ext>
            </a:extLst>
          </p:cNvPr>
          <p:cNvSpPr txBox="1"/>
          <p:nvPr/>
        </p:nvSpPr>
        <p:spPr>
          <a:xfrm>
            <a:off x="0" y="0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lx2oe E15-E16</a:t>
            </a:r>
          </a:p>
        </p:txBody>
      </p:sp>
    </p:spTree>
    <p:extLst>
      <p:ext uri="{BB962C8B-B14F-4D97-AF65-F5344CB8AC3E}">
        <p14:creationId xmlns:p14="http://schemas.microsoft.com/office/powerpoint/2010/main" val="7145433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FD996080-8ED1-848C-0241-A3A9F0FC2B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7197">
            <a:off x="2573504" y="674869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0F2C96-FC87-DCA5-172B-EA217D1FF36A}"/>
              </a:ext>
            </a:extLst>
          </p:cNvPr>
          <p:cNvSpPr txBox="1"/>
          <p:nvPr/>
        </p:nvSpPr>
        <p:spPr>
          <a:xfrm>
            <a:off x="0" y="0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lx2oe E15-E16</a:t>
            </a:r>
          </a:p>
        </p:txBody>
      </p:sp>
    </p:spTree>
    <p:extLst>
      <p:ext uri="{BB962C8B-B14F-4D97-AF65-F5344CB8AC3E}">
        <p14:creationId xmlns:p14="http://schemas.microsoft.com/office/powerpoint/2010/main" val="10659016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AE6DCE07-7520-9670-BD47-B2B4AF165F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35406">
            <a:off x="2573915" y="675296"/>
            <a:ext cx="5940000" cy="5895616"/>
          </a:xfrm>
          <a:prstGeom prst="rect">
            <a:avLst/>
          </a:prstGeom>
        </p:spPr>
      </p:pic>
      <p:sp>
        <p:nvSpPr>
          <p:cNvPr id="12" name="직사각형 11">
            <a:extLst>
              <a:ext uri="{FF2B5EF4-FFF2-40B4-BE49-F238E27FC236}">
                <a16:creationId xmlns:a16="http://schemas.microsoft.com/office/drawing/2014/main" id="{0316AFDD-FDB9-7F50-E48A-EFABBE6ABE45}"/>
              </a:ext>
            </a:extLst>
          </p:cNvPr>
          <p:cNvSpPr/>
          <p:nvPr/>
        </p:nvSpPr>
        <p:spPr>
          <a:xfrm>
            <a:off x="3368587" y="2185395"/>
            <a:ext cx="4812887" cy="2487209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0F2C96-FC87-DCA5-172B-EA217D1FF36A}"/>
              </a:ext>
            </a:extLst>
          </p:cNvPr>
          <p:cNvSpPr txBox="1"/>
          <p:nvPr/>
        </p:nvSpPr>
        <p:spPr>
          <a:xfrm>
            <a:off x="0" y="0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lx2oe E15-E16</a:t>
            </a:r>
          </a:p>
        </p:txBody>
      </p:sp>
    </p:spTree>
    <p:extLst>
      <p:ext uri="{BB962C8B-B14F-4D97-AF65-F5344CB8AC3E}">
        <p14:creationId xmlns:p14="http://schemas.microsoft.com/office/powerpoint/2010/main" val="419378095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4B02597A-B231-7098-91D1-9CBFDCA4AA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C125FB85-7399-7B1D-60FD-E687958934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F6B5843B-E0E0-02E5-ED30-4E676B271C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F70FE830-C31E-47A0-3084-DA63427807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0B4AFE44-4006-27C4-BF36-5E4DDF9D0476}"/>
              </a:ext>
            </a:extLst>
          </p:cNvPr>
          <p:cNvSpPr/>
          <p:nvPr/>
        </p:nvSpPr>
        <p:spPr>
          <a:xfrm>
            <a:off x="3612000" y="539502"/>
            <a:ext cx="4968000" cy="4968000"/>
          </a:xfrm>
          <a:prstGeom prst="rect">
            <a:avLst/>
          </a:prstGeom>
          <a:noFill/>
          <a:ln>
            <a:solidFill>
              <a:schemeClr val="bg1">
                <a:lumMod val="9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64769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7</TotalTime>
  <Words>10</Words>
  <Application>Microsoft Office PowerPoint</Application>
  <PresentationFormat>와이드스크린</PresentationFormat>
  <Paragraphs>5</Paragraphs>
  <Slides>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2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22</cp:revision>
  <cp:lastPrinted>2022-10-28T05:42:19Z</cp:lastPrinted>
  <dcterms:created xsi:type="dcterms:W3CDTF">2022-08-01T11:36:47Z</dcterms:created>
  <dcterms:modified xsi:type="dcterms:W3CDTF">2024-09-30T06:47:48Z</dcterms:modified>
</cp:coreProperties>
</file>